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4" r:id="rId2"/>
    <p:sldId id="266" r:id="rId3"/>
    <p:sldId id="267" r:id="rId4"/>
    <p:sldId id="261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3" d="100"/>
          <a:sy n="113" d="100"/>
        </p:scale>
        <p:origin x="802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10D267-8CF3-4B6C-822B-06E3DF8701F1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FA1B76F-919F-47B2-A9A3-BE8261E43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68731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5C013E0-D038-40D9-B680-24C6F122E4FB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042363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5C013E0-D038-40D9-B680-24C6F122E4FB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888893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5C013E0-D038-40D9-B680-24C6F122E4FB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71539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92954C-C3FF-1844-82AF-AA7F5D5F2F2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A9C3F84-62AF-C855-ABA5-1D1BB6EC31A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F4C2288-B987-25BE-5F9B-3F370EA913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E3CC2-3FDB-44C1-8176-A8B9EE2EFB96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532BA11-FF99-69BE-C9CF-643317C172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71F5E8F-29CD-B8F1-DE92-35E246FFFA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43897-26E5-4106-AB26-3D0468D6C5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3193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D4E13D-DE06-A9EE-87E0-DB7250388C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C5F82C4-9448-0CDF-5DDB-667EC3C88F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D4B7D8-1B92-7083-E4CD-59278283C2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E3CC2-3FDB-44C1-8176-A8B9EE2EFB96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FA1369A-5E9A-4F4A-6B1D-180F360C7E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810DDE1-7C80-3186-5B64-46C2C57EF6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43897-26E5-4106-AB26-3D0468D6C5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15277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A7EB3A5-D11C-04B7-8C4C-DD1A9750148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1EF3D5F-0C6F-F7E1-1B01-04B89E2F6B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02E8D06-D83D-5792-4B63-C5ED1B53E9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E3CC2-3FDB-44C1-8176-A8B9EE2EFB96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A73C805-14B0-FAD2-B8CF-EA82F7AB0A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FC030AD-CE4C-35F2-9CFE-0FC538B58B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43897-26E5-4106-AB26-3D0468D6C5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50831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844474-2B41-D5BA-87ED-A6A7BD9615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EA14348-9C02-F23A-2E1C-32C9F933D40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7CE3892-A554-211C-A393-C18144156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E3CC2-3FDB-44C1-8176-A8B9EE2EFB96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08AF2F5-99EE-5D3F-73C0-5329EA40DD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1121AB-5779-C727-B24D-D9A60E3B1D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43897-26E5-4106-AB26-3D0468D6C5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9606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B2B6FD8-FB2D-5455-781D-C851E7CEB4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B364E50-6744-9AC5-3ACC-AD36E19935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211DC61-C2D7-67B0-53B8-CCEC659061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E3CC2-3FDB-44C1-8176-A8B9EE2EFB96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5098E32-100E-1261-364E-4910744044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39A0D73-B67A-9746-9CA9-F6E79CE374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43897-26E5-4106-AB26-3D0468D6C5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2743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B30A26E-1D25-EC5C-C084-7040703160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AF4828E-25C2-94EC-B1B6-C0B5F07A54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F42DACF-068D-E91F-8DF6-523E8BFD19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0CAC371-C87E-2803-C459-79ADF46FA4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E3CC2-3FDB-44C1-8176-A8B9EE2EFB96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2DB40F6-7ED2-C0DE-BFA7-22C115D0BB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F03CFF8-5C3E-C153-2AD8-D3593C1C95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43897-26E5-4106-AB26-3D0468D6C5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6047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63592F-4E7A-0586-4AA1-3982E38C46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59C8B49-A75D-52DE-0325-790EAA2D67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821DA43-D7D4-1E06-3696-F381AD8D4B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C0DA474-D81E-9E12-DF27-01265630204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8327EC3-5138-CCF8-91E0-224B4C4FA2E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274DD4D-4B93-10F0-0BEB-C9FEFE1B23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E3CC2-3FDB-44C1-8176-A8B9EE2EFB96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065FBFE-334F-4065-BBFA-B40D5BBAF2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397C66A-0328-0969-7619-50EB4593DE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43897-26E5-4106-AB26-3D0468D6C5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93054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B8C0F4B-C9F3-F2B7-71B8-95114D759C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E6DEAD5-AD00-6584-01AA-EBF979503A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E3CC2-3FDB-44C1-8176-A8B9EE2EFB96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BD74E39-77A6-7D86-57C0-206FF82888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E5561C8-850F-E4DA-0D6F-C51E8C9679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43897-26E5-4106-AB26-3D0468D6C5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01035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6C2815C-9E61-8F4A-8B28-9C8BC153D1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E3CC2-3FDB-44C1-8176-A8B9EE2EFB96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F56C185-6BD9-47B9-3179-EFE200897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718BC9D-51C3-BA4F-7D31-4A5CED8E3B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43897-26E5-4106-AB26-3D0468D6C5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97485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15B0D6F-44E6-DC2B-EF1E-9C600C0D0F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F49EE9E-A752-BD52-7224-B9C6382336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B6BCCDB-680A-BB26-F93F-A19406AD70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9E14B7B-16C4-28B7-9036-79DB9D0A98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E3CC2-3FDB-44C1-8176-A8B9EE2EFB96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EABD7AA-C7D0-B819-CC06-DDD5AF7053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07D524C-C407-BAAE-B969-4AB89C6B29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43897-26E5-4106-AB26-3D0468D6C5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1761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CC9A56D-FD36-0BD3-3910-D5DB8FC402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11ACC3B-6EB9-CAFB-C6DD-751BFCDE6E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672E812-91C7-C34D-C59D-49BC110A77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7E4B858-7723-2A87-FCD3-4BB13771F5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E3CC2-3FDB-44C1-8176-A8B9EE2EFB96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A1ACCFE-B742-9142-A257-9335F9F901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69AFA10-3E91-E54B-CB2B-C74C7B7B98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643897-26E5-4106-AB26-3D0468D6C5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25380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0529420-5FA3-69FD-142E-6892AFEED5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736BB47-F639-917E-DF63-622B23746F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8BE1A33-4DBF-7A2C-2846-6020AA138CA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2E3CC2-3FDB-44C1-8176-A8B9EE2EFB96}" type="datetimeFigureOut">
              <a:rPr lang="zh-CN" altLang="en-US" smtClean="0"/>
              <a:t>2023/8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8E4CDEB-3378-5C56-7B46-B303C0A1B0C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C106331-020F-BFF8-E5FD-F2F146FAA3F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643897-26E5-4106-AB26-3D0468D6C5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48108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image" Target="../media/image6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microsoft.com/office/2007/relationships/hdphoto" Target="../media/hdphoto5.wdp"/><Relationship Id="rId5" Type="http://schemas.openxmlformats.org/officeDocument/2006/relationships/image" Target="../media/image5.png"/><Relationship Id="rId4" Type="http://schemas.microsoft.com/office/2007/relationships/hdphoto" Target="../media/hdphoto4.wdp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8.wdp"/><Relationship Id="rId3" Type="http://schemas.openxmlformats.org/officeDocument/2006/relationships/image" Target="../media/image7.png"/><Relationship Id="rId7" Type="http://schemas.openxmlformats.org/officeDocument/2006/relationships/image" Target="../media/image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microsoft.com/office/2007/relationships/hdphoto" Target="../media/hdphoto7.wdp"/><Relationship Id="rId5" Type="http://schemas.openxmlformats.org/officeDocument/2006/relationships/image" Target="../media/image8.png"/><Relationship Id="rId4" Type="http://schemas.microsoft.com/office/2007/relationships/hdphoto" Target="../media/hdphoto6.wdp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文本框 50">
            <a:extLst>
              <a:ext uri="{FF2B5EF4-FFF2-40B4-BE49-F238E27FC236}">
                <a16:creationId xmlns:a16="http://schemas.microsoft.com/office/drawing/2014/main" id="{3F4F925C-3FCC-163C-6D1E-93706E19215C}"/>
              </a:ext>
            </a:extLst>
          </p:cNvPr>
          <p:cNvSpPr txBox="1"/>
          <p:nvPr/>
        </p:nvSpPr>
        <p:spPr>
          <a:xfrm>
            <a:off x="172964" y="106103"/>
            <a:ext cx="2441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6d. Replicate 1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57" name="组合 56">
            <a:extLst>
              <a:ext uri="{FF2B5EF4-FFF2-40B4-BE49-F238E27FC236}">
                <a16:creationId xmlns:a16="http://schemas.microsoft.com/office/drawing/2014/main" id="{BF03D053-F4EF-6A83-344F-9DB1C10E0F1E}"/>
              </a:ext>
            </a:extLst>
          </p:cNvPr>
          <p:cNvGrpSpPr/>
          <p:nvPr/>
        </p:nvGrpSpPr>
        <p:grpSpPr>
          <a:xfrm>
            <a:off x="3790547" y="1840430"/>
            <a:ext cx="4102698" cy="2681056"/>
            <a:chOff x="3790547" y="1840430"/>
            <a:chExt cx="4102698" cy="2681056"/>
          </a:xfrm>
        </p:grpSpPr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2BE127FC-3223-FE16-F6FF-76DAE6BC5132}"/>
                </a:ext>
              </a:extLst>
            </p:cNvPr>
            <p:cNvSpPr txBox="1"/>
            <p:nvPr/>
          </p:nvSpPr>
          <p:spPr>
            <a:xfrm>
              <a:off x="6798737" y="2556568"/>
              <a:ext cx="8258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MYH9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023D8D48-4018-1EEC-5F5D-33F9A97BEBCC}"/>
                </a:ext>
              </a:extLst>
            </p:cNvPr>
            <p:cNvSpPr txBox="1"/>
            <p:nvPr/>
          </p:nvSpPr>
          <p:spPr>
            <a:xfrm>
              <a:off x="6798737" y="3294102"/>
              <a:ext cx="109450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Emerin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FCB8FF8C-3B30-2B1E-3AEE-AFF6DBAEB3D9}"/>
                </a:ext>
              </a:extLst>
            </p:cNvPr>
            <p:cNvSpPr txBox="1"/>
            <p:nvPr/>
          </p:nvSpPr>
          <p:spPr>
            <a:xfrm>
              <a:off x="3868192" y="3137527"/>
              <a:ext cx="773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1 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CD1393A8-3CFA-581B-A6B2-E536BC85A27D}"/>
                </a:ext>
              </a:extLst>
            </p:cNvPr>
            <p:cNvSpPr txBox="1"/>
            <p:nvPr/>
          </p:nvSpPr>
          <p:spPr>
            <a:xfrm>
              <a:off x="3858319" y="3478825"/>
              <a:ext cx="773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B842FB01-5C5B-CF7B-EF0B-AB4BD9D8DC38}"/>
                </a:ext>
              </a:extLst>
            </p:cNvPr>
            <p:cNvSpPr txBox="1"/>
            <p:nvPr/>
          </p:nvSpPr>
          <p:spPr>
            <a:xfrm>
              <a:off x="3794702" y="2744135"/>
              <a:ext cx="8859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1418EAB2-462E-233E-765D-F8B2A1628571}"/>
                </a:ext>
              </a:extLst>
            </p:cNvPr>
            <p:cNvSpPr txBox="1"/>
            <p:nvPr/>
          </p:nvSpPr>
          <p:spPr>
            <a:xfrm>
              <a:off x="3790547" y="2464235"/>
              <a:ext cx="8859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40 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52DD2861-B6ED-BF86-68CF-D07C4C7AFE00}"/>
                </a:ext>
              </a:extLst>
            </p:cNvPr>
            <p:cNvSpPr txBox="1"/>
            <p:nvPr/>
          </p:nvSpPr>
          <p:spPr>
            <a:xfrm>
              <a:off x="4392751" y="2227457"/>
              <a:ext cx="4331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F08CA175-C00A-CFEE-8DFA-F12F7561BA1B}"/>
                </a:ext>
              </a:extLst>
            </p:cNvPr>
            <p:cNvSpPr txBox="1"/>
            <p:nvPr/>
          </p:nvSpPr>
          <p:spPr>
            <a:xfrm>
              <a:off x="3959859" y="2219318"/>
              <a:ext cx="4235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Glu</a:t>
              </a: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D966BCA7-6E21-6C5D-42FE-C78431A1BA08}"/>
                </a:ext>
              </a:extLst>
            </p:cNvPr>
            <p:cNvSpPr txBox="1"/>
            <p:nvPr/>
          </p:nvSpPr>
          <p:spPr>
            <a:xfrm>
              <a:off x="4850650" y="2191228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AF15284D-3012-1462-B08C-31A7DBEBB150}"/>
                </a:ext>
              </a:extLst>
            </p:cNvPr>
            <p:cNvSpPr txBox="1"/>
            <p:nvPr/>
          </p:nvSpPr>
          <p:spPr>
            <a:xfrm>
              <a:off x="5202409" y="2201675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95DF501F-2413-BDCC-EAEC-D92D24A0B901}"/>
                </a:ext>
              </a:extLst>
            </p:cNvPr>
            <p:cNvCxnSpPr>
              <a:cxnSpLocks/>
            </p:cNvCxnSpPr>
            <p:nvPr/>
          </p:nvCxnSpPr>
          <p:spPr>
            <a:xfrm>
              <a:off x="4327927" y="2182287"/>
              <a:ext cx="120344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A064566A-545D-20A7-E47F-1F73D5811085}"/>
                </a:ext>
              </a:extLst>
            </p:cNvPr>
            <p:cNvCxnSpPr>
              <a:cxnSpLocks/>
            </p:cNvCxnSpPr>
            <p:nvPr/>
          </p:nvCxnSpPr>
          <p:spPr>
            <a:xfrm>
              <a:off x="5694650" y="2182287"/>
              <a:ext cx="93179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CD045680-A16B-D47F-3955-10A1E29864B7}"/>
                </a:ext>
              </a:extLst>
            </p:cNvPr>
            <p:cNvSpPr txBox="1"/>
            <p:nvPr/>
          </p:nvSpPr>
          <p:spPr>
            <a:xfrm>
              <a:off x="4450727" y="1846306"/>
              <a:ext cx="9028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P-</a:t>
              </a:r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merin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EF945F8D-AE9D-1F83-96BD-B9DE46D4A55D}"/>
                </a:ext>
              </a:extLst>
            </p:cNvPr>
            <p:cNvSpPr txBox="1"/>
            <p:nvPr/>
          </p:nvSpPr>
          <p:spPr>
            <a:xfrm>
              <a:off x="5812892" y="1840430"/>
              <a:ext cx="56297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270C08E5-6900-0B7E-7001-BF3EC672D77E}"/>
                </a:ext>
              </a:extLst>
            </p:cNvPr>
            <p:cNvSpPr txBox="1"/>
            <p:nvPr/>
          </p:nvSpPr>
          <p:spPr>
            <a:xfrm>
              <a:off x="3868192" y="4244487"/>
              <a:ext cx="773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1 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A3F87679-75B1-C3B9-C7B1-FEE47FB76938}"/>
                </a:ext>
              </a:extLst>
            </p:cNvPr>
            <p:cNvSpPr txBox="1"/>
            <p:nvPr/>
          </p:nvSpPr>
          <p:spPr>
            <a:xfrm>
              <a:off x="3868192" y="3906108"/>
              <a:ext cx="773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952D4AA0-CD39-DE5A-FB56-62DDC0D214B4}"/>
                </a:ext>
              </a:extLst>
            </p:cNvPr>
            <p:cNvSpPr txBox="1"/>
            <p:nvPr/>
          </p:nvSpPr>
          <p:spPr>
            <a:xfrm>
              <a:off x="6798737" y="4039195"/>
              <a:ext cx="109450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0" name="组合 49">
              <a:extLst>
                <a:ext uri="{FF2B5EF4-FFF2-40B4-BE49-F238E27FC236}">
                  <a16:creationId xmlns:a16="http://schemas.microsoft.com/office/drawing/2014/main" id="{0677CEF8-3A1C-ED2F-540F-884DD67DDE5C}"/>
                </a:ext>
              </a:extLst>
            </p:cNvPr>
            <p:cNvGrpSpPr/>
            <p:nvPr/>
          </p:nvGrpSpPr>
          <p:grpSpPr>
            <a:xfrm>
              <a:off x="4441387" y="2604657"/>
              <a:ext cx="2288362" cy="1811408"/>
              <a:chOff x="6329691" y="3068227"/>
              <a:chExt cx="1784087" cy="1412237"/>
            </a:xfrm>
          </p:grpSpPr>
          <p:pic>
            <p:nvPicPr>
              <p:cNvPr id="52" name="图片 51">
                <a:extLst>
                  <a:ext uri="{FF2B5EF4-FFF2-40B4-BE49-F238E27FC236}">
                    <a16:creationId xmlns:a16="http://schemas.microsoft.com/office/drawing/2014/main" id="{DE64FB64-EDCA-FA7E-6BA5-E48403A28A7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652" t="43987" r="36648" b="52749"/>
              <a:stretch/>
            </p:blipFill>
            <p:spPr>
              <a:xfrm>
                <a:off x="6341777" y="3068227"/>
                <a:ext cx="1736348" cy="243392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53" name="图片 52">
                <a:extLst>
                  <a:ext uri="{FF2B5EF4-FFF2-40B4-BE49-F238E27FC236}">
                    <a16:creationId xmlns:a16="http://schemas.microsoft.com/office/drawing/2014/main" id="{CC1A8091-B4A6-5056-E4A5-AFD36F7CC63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2227" t="55156" r="36845" b="40728"/>
              <a:stretch/>
            </p:blipFill>
            <p:spPr>
              <a:xfrm>
                <a:off x="6340010" y="3598698"/>
                <a:ext cx="1773768" cy="294989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54" name="图片 53">
                <a:extLst>
                  <a:ext uri="{FF2B5EF4-FFF2-40B4-BE49-F238E27FC236}">
                    <a16:creationId xmlns:a16="http://schemas.microsoft.com/office/drawing/2014/main" id="{CEC727D2-88EB-8AF1-A195-A2D3E5281B0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982" t="51081" r="42213" b="44391"/>
              <a:stretch/>
            </p:blipFill>
            <p:spPr>
              <a:xfrm>
                <a:off x="6329691" y="4180767"/>
                <a:ext cx="1784087" cy="299697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</p:grp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07CE1DD6-374D-6411-2798-D3453199F031}"/>
                </a:ext>
              </a:extLst>
            </p:cNvPr>
            <p:cNvSpPr txBox="1"/>
            <p:nvPr/>
          </p:nvSpPr>
          <p:spPr>
            <a:xfrm>
              <a:off x="5789916" y="2177564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CE7DCA4F-DE3B-83B0-F6F9-BCD03946E9B9}"/>
                </a:ext>
              </a:extLst>
            </p:cNvPr>
            <p:cNvSpPr txBox="1"/>
            <p:nvPr/>
          </p:nvSpPr>
          <p:spPr>
            <a:xfrm>
              <a:off x="6141675" y="2188011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592171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文本框 50">
            <a:extLst>
              <a:ext uri="{FF2B5EF4-FFF2-40B4-BE49-F238E27FC236}">
                <a16:creationId xmlns:a16="http://schemas.microsoft.com/office/drawing/2014/main" id="{3F4F925C-3FCC-163C-6D1E-93706E19215C}"/>
              </a:ext>
            </a:extLst>
          </p:cNvPr>
          <p:cNvSpPr txBox="1"/>
          <p:nvPr/>
        </p:nvSpPr>
        <p:spPr>
          <a:xfrm>
            <a:off x="172964" y="106103"/>
            <a:ext cx="2441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6d. Replicate 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18" name="组合 17">
            <a:extLst>
              <a:ext uri="{FF2B5EF4-FFF2-40B4-BE49-F238E27FC236}">
                <a16:creationId xmlns:a16="http://schemas.microsoft.com/office/drawing/2014/main" id="{3D2E5944-29D4-5743-C98A-7A8305737595}"/>
              </a:ext>
            </a:extLst>
          </p:cNvPr>
          <p:cNvGrpSpPr/>
          <p:nvPr/>
        </p:nvGrpSpPr>
        <p:grpSpPr>
          <a:xfrm>
            <a:off x="3802177" y="1840430"/>
            <a:ext cx="4091068" cy="2681056"/>
            <a:chOff x="3802177" y="1840430"/>
            <a:chExt cx="4091068" cy="2681056"/>
          </a:xfrm>
        </p:grpSpPr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2BE127FC-3223-FE16-F6FF-76DAE6BC5132}"/>
                </a:ext>
              </a:extLst>
            </p:cNvPr>
            <p:cNvSpPr txBox="1"/>
            <p:nvPr/>
          </p:nvSpPr>
          <p:spPr>
            <a:xfrm>
              <a:off x="6798737" y="2556568"/>
              <a:ext cx="8258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MYH9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023D8D48-4018-1EEC-5F5D-33F9A97BEBCC}"/>
                </a:ext>
              </a:extLst>
            </p:cNvPr>
            <p:cNvSpPr txBox="1"/>
            <p:nvPr/>
          </p:nvSpPr>
          <p:spPr>
            <a:xfrm>
              <a:off x="6798737" y="3294102"/>
              <a:ext cx="109450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Emerin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FCB8FF8C-3B30-2B1E-3AEE-AFF6DBAEB3D9}"/>
                </a:ext>
              </a:extLst>
            </p:cNvPr>
            <p:cNvSpPr txBox="1"/>
            <p:nvPr/>
          </p:nvSpPr>
          <p:spPr>
            <a:xfrm>
              <a:off x="3868192" y="3178732"/>
              <a:ext cx="773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1 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CD1393A8-3CFA-581B-A6B2-E536BC85A27D}"/>
                </a:ext>
              </a:extLst>
            </p:cNvPr>
            <p:cNvSpPr txBox="1"/>
            <p:nvPr/>
          </p:nvSpPr>
          <p:spPr>
            <a:xfrm>
              <a:off x="3868192" y="3515088"/>
              <a:ext cx="773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B842FB01-5C5B-CF7B-EF0B-AB4BD9D8DC38}"/>
                </a:ext>
              </a:extLst>
            </p:cNvPr>
            <p:cNvSpPr txBox="1"/>
            <p:nvPr/>
          </p:nvSpPr>
          <p:spPr>
            <a:xfrm>
              <a:off x="3812050" y="2869845"/>
              <a:ext cx="8859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1418EAB2-462E-233E-765D-F8B2A1628571}"/>
                </a:ext>
              </a:extLst>
            </p:cNvPr>
            <p:cNvSpPr txBox="1"/>
            <p:nvPr/>
          </p:nvSpPr>
          <p:spPr>
            <a:xfrm>
              <a:off x="3802177" y="2491506"/>
              <a:ext cx="8859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40 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52DD2861-B6ED-BF86-68CF-D07C4C7AFE00}"/>
                </a:ext>
              </a:extLst>
            </p:cNvPr>
            <p:cNvSpPr txBox="1"/>
            <p:nvPr/>
          </p:nvSpPr>
          <p:spPr>
            <a:xfrm>
              <a:off x="4448167" y="2227457"/>
              <a:ext cx="4331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F08CA175-C00A-CFEE-8DFA-F12F7561BA1B}"/>
                </a:ext>
              </a:extLst>
            </p:cNvPr>
            <p:cNvSpPr txBox="1"/>
            <p:nvPr/>
          </p:nvSpPr>
          <p:spPr>
            <a:xfrm>
              <a:off x="3959859" y="2219318"/>
              <a:ext cx="4235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Glu</a:t>
              </a: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D966BCA7-6E21-6C5D-42FE-C78431A1BA08}"/>
                </a:ext>
              </a:extLst>
            </p:cNvPr>
            <p:cNvSpPr txBox="1"/>
            <p:nvPr/>
          </p:nvSpPr>
          <p:spPr>
            <a:xfrm>
              <a:off x="4906066" y="2191228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AF15284D-3012-1462-B08C-31A7DBEBB150}"/>
                </a:ext>
              </a:extLst>
            </p:cNvPr>
            <p:cNvSpPr txBox="1"/>
            <p:nvPr/>
          </p:nvSpPr>
          <p:spPr>
            <a:xfrm>
              <a:off x="5257825" y="2201675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95DF501F-2413-BDCC-EAEC-D92D24A0B901}"/>
                </a:ext>
              </a:extLst>
            </p:cNvPr>
            <p:cNvCxnSpPr>
              <a:cxnSpLocks/>
            </p:cNvCxnSpPr>
            <p:nvPr/>
          </p:nvCxnSpPr>
          <p:spPr>
            <a:xfrm>
              <a:off x="4383343" y="2182287"/>
              <a:ext cx="120344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A064566A-545D-20A7-E47F-1F73D5811085}"/>
                </a:ext>
              </a:extLst>
            </p:cNvPr>
            <p:cNvCxnSpPr>
              <a:cxnSpLocks/>
            </p:cNvCxnSpPr>
            <p:nvPr/>
          </p:nvCxnSpPr>
          <p:spPr>
            <a:xfrm>
              <a:off x="5750066" y="2182287"/>
              <a:ext cx="93179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CD045680-A16B-D47F-3955-10A1E29864B7}"/>
                </a:ext>
              </a:extLst>
            </p:cNvPr>
            <p:cNvSpPr txBox="1"/>
            <p:nvPr/>
          </p:nvSpPr>
          <p:spPr>
            <a:xfrm>
              <a:off x="4506143" y="1846306"/>
              <a:ext cx="9028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P-</a:t>
              </a:r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merin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EF945F8D-AE9D-1F83-96BD-B9DE46D4A55D}"/>
                </a:ext>
              </a:extLst>
            </p:cNvPr>
            <p:cNvSpPr txBox="1"/>
            <p:nvPr/>
          </p:nvSpPr>
          <p:spPr>
            <a:xfrm>
              <a:off x="5868308" y="1840430"/>
              <a:ext cx="56297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270C08E5-6900-0B7E-7001-BF3EC672D77E}"/>
                </a:ext>
              </a:extLst>
            </p:cNvPr>
            <p:cNvSpPr txBox="1"/>
            <p:nvPr/>
          </p:nvSpPr>
          <p:spPr>
            <a:xfrm>
              <a:off x="3868192" y="4244487"/>
              <a:ext cx="773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1 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A3F87679-75B1-C3B9-C7B1-FEE47FB76938}"/>
                </a:ext>
              </a:extLst>
            </p:cNvPr>
            <p:cNvSpPr txBox="1"/>
            <p:nvPr/>
          </p:nvSpPr>
          <p:spPr>
            <a:xfrm>
              <a:off x="3868192" y="3906108"/>
              <a:ext cx="773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952D4AA0-CD39-DE5A-FB56-62DDC0D214B4}"/>
                </a:ext>
              </a:extLst>
            </p:cNvPr>
            <p:cNvSpPr txBox="1"/>
            <p:nvPr/>
          </p:nvSpPr>
          <p:spPr>
            <a:xfrm>
              <a:off x="6798737" y="4039195"/>
              <a:ext cx="109450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07CE1DD6-374D-6411-2798-D3453199F031}"/>
                </a:ext>
              </a:extLst>
            </p:cNvPr>
            <p:cNvSpPr txBox="1"/>
            <p:nvPr/>
          </p:nvSpPr>
          <p:spPr>
            <a:xfrm>
              <a:off x="5845332" y="2177564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CE7DCA4F-DE3B-83B0-F6F9-BCD03946E9B9}"/>
                </a:ext>
              </a:extLst>
            </p:cNvPr>
            <p:cNvSpPr txBox="1"/>
            <p:nvPr/>
          </p:nvSpPr>
          <p:spPr>
            <a:xfrm>
              <a:off x="6197091" y="2188011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2099A7D8-1091-1AD5-4E1E-CEA94F72C3A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011" t="47242" r="39219" b="47611"/>
            <a:stretch/>
          </p:blipFill>
          <p:spPr>
            <a:xfrm>
              <a:off x="4506143" y="2552372"/>
              <a:ext cx="2175719" cy="533092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C4C9630D-810E-03BB-D340-8435C53E6F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380" t="39312" r="34233" b="55534"/>
            <a:stretch/>
          </p:blipFill>
          <p:spPr>
            <a:xfrm>
              <a:off x="4496803" y="3256723"/>
              <a:ext cx="2185059" cy="425485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90225B36-2F90-58CB-D544-0F151B5C3E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806" t="43103" r="30433" b="50995"/>
            <a:stretch/>
          </p:blipFill>
          <p:spPr>
            <a:xfrm>
              <a:off x="4496802" y="3967488"/>
              <a:ext cx="2185059" cy="504484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32954604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文本框 50">
            <a:extLst>
              <a:ext uri="{FF2B5EF4-FFF2-40B4-BE49-F238E27FC236}">
                <a16:creationId xmlns:a16="http://schemas.microsoft.com/office/drawing/2014/main" id="{3F4F925C-3FCC-163C-6D1E-93706E19215C}"/>
              </a:ext>
            </a:extLst>
          </p:cNvPr>
          <p:cNvSpPr txBox="1"/>
          <p:nvPr/>
        </p:nvSpPr>
        <p:spPr>
          <a:xfrm>
            <a:off x="172964" y="106103"/>
            <a:ext cx="2441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6d. Replicate 3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2BE127FC-3223-FE16-F6FF-76DAE6BC5132}"/>
              </a:ext>
            </a:extLst>
          </p:cNvPr>
          <p:cNvSpPr txBox="1"/>
          <p:nvPr/>
        </p:nvSpPr>
        <p:spPr>
          <a:xfrm>
            <a:off x="6798737" y="2556568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YH9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023D8D48-4018-1EEC-5F5D-33F9A97BEBCC}"/>
              </a:ext>
            </a:extLst>
          </p:cNvPr>
          <p:cNvSpPr txBox="1"/>
          <p:nvPr/>
        </p:nvSpPr>
        <p:spPr>
          <a:xfrm>
            <a:off x="6798737" y="3294102"/>
            <a:ext cx="109450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Emer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FCB8FF8C-3B30-2B1E-3AEE-AFF6DBAEB3D9}"/>
              </a:ext>
            </a:extLst>
          </p:cNvPr>
          <p:cNvSpPr txBox="1"/>
          <p:nvPr/>
        </p:nvSpPr>
        <p:spPr>
          <a:xfrm>
            <a:off x="3868192" y="3178732"/>
            <a:ext cx="7736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1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D1393A8-3CFA-581B-A6B2-E536BC85A27D}"/>
              </a:ext>
            </a:extLst>
          </p:cNvPr>
          <p:cNvSpPr txBox="1"/>
          <p:nvPr/>
        </p:nvSpPr>
        <p:spPr>
          <a:xfrm>
            <a:off x="3868192" y="3515088"/>
            <a:ext cx="7736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842FB01-5C5B-CF7B-EF0B-AB4BD9D8DC38}"/>
              </a:ext>
            </a:extLst>
          </p:cNvPr>
          <p:cNvSpPr txBox="1"/>
          <p:nvPr/>
        </p:nvSpPr>
        <p:spPr>
          <a:xfrm>
            <a:off x="3812050" y="2869845"/>
            <a:ext cx="885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418EAB2-462E-233E-765D-F8B2A1628571}"/>
              </a:ext>
            </a:extLst>
          </p:cNvPr>
          <p:cNvSpPr txBox="1"/>
          <p:nvPr/>
        </p:nvSpPr>
        <p:spPr>
          <a:xfrm>
            <a:off x="3802177" y="2491506"/>
            <a:ext cx="885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2DD2861-B6ED-BF86-68CF-D07C4C7AFE00}"/>
              </a:ext>
            </a:extLst>
          </p:cNvPr>
          <p:cNvSpPr txBox="1"/>
          <p:nvPr/>
        </p:nvSpPr>
        <p:spPr>
          <a:xfrm>
            <a:off x="4529443" y="2227457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08CA175-C00A-CFEE-8DFA-F12F7561BA1B}"/>
              </a:ext>
            </a:extLst>
          </p:cNvPr>
          <p:cNvSpPr txBox="1"/>
          <p:nvPr/>
        </p:nvSpPr>
        <p:spPr>
          <a:xfrm>
            <a:off x="3959859" y="2219318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lu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D966BCA7-6E21-6C5D-42FE-C78431A1BA08}"/>
              </a:ext>
            </a:extLst>
          </p:cNvPr>
          <p:cNvSpPr txBox="1"/>
          <p:nvPr/>
        </p:nvSpPr>
        <p:spPr>
          <a:xfrm>
            <a:off x="5061845" y="2191228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AF15284D-3012-1462-B08C-31A7DBEBB150}"/>
              </a:ext>
            </a:extLst>
          </p:cNvPr>
          <p:cNvSpPr txBox="1"/>
          <p:nvPr/>
        </p:nvSpPr>
        <p:spPr>
          <a:xfrm>
            <a:off x="5413604" y="2201675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95DF501F-2413-BDCC-EAEC-D92D24A0B901}"/>
              </a:ext>
            </a:extLst>
          </p:cNvPr>
          <p:cNvCxnSpPr>
            <a:cxnSpLocks/>
          </p:cNvCxnSpPr>
          <p:nvPr/>
        </p:nvCxnSpPr>
        <p:spPr>
          <a:xfrm>
            <a:off x="4464619" y="2182287"/>
            <a:ext cx="120344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A064566A-545D-20A7-E47F-1F73D5811085}"/>
              </a:ext>
            </a:extLst>
          </p:cNvPr>
          <p:cNvCxnSpPr>
            <a:cxnSpLocks/>
          </p:cNvCxnSpPr>
          <p:nvPr/>
        </p:nvCxnSpPr>
        <p:spPr>
          <a:xfrm>
            <a:off x="5831342" y="2182287"/>
            <a:ext cx="9317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id="{CD045680-A16B-D47F-3955-10A1E29864B7}"/>
              </a:ext>
            </a:extLst>
          </p:cNvPr>
          <p:cNvSpPr txBox="1"/>
          <p:nvPr/>
        </p:nvSpPr>
        <p:spPr>
          <a:xfrm>
            <a:off x="4587419" y="1846306"/>
            <a:ext cx="9028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IP-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merin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EF945F8D-AE9D-1F83-96BD-B9DE46D4A55D}"/>
              </a:ext>
            </a:extLst>
          </p:cNvPr>
          <p:cNvSpPr txBox="1"/>
          <p:nvPr/>
        </p:nvSpPr>
        <p:spPr>
          <a:xfrm>
            <a:off x="5949584" y="1840430"/>
            <a:ext cx="5629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270C08E5-6900-0B7E-7001-BF3EC672D77E}"/>
              </a:ext>
            </a:extLst>
          </p:cNvPr>
          <p:cNvSpPr txBox="1"/>
          <p:nvPr/>
        </p:nvSpPr>
        <p:spPr>
          <a:xfrm>
            <a:off x="3868192" y="4202925"/>
            <a:ext cx="7736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1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A3F87679-75B1-C3B9-C7B1-FEE47FB76938}"/>
              </a:ext>
            </a:extLst>
          </p:cNvPr>
          <p:cNvSpPr txBox="1"/>
          <p:nvPr/>
        </p:nvSpPr>
        <p:spPr>
          <a:xfrm>
            <a:off x="3868192" y="3906108"/>
            <a:ext cx="7736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952D4AA0-CD39-DE5A-FB56-62DDC0D214B4}"/>
              </a:ext>
            </a:extLst>
          </p:cNvPr>
          <p:cNvSpPr txBox="1"/>
          <p:nvPr/>
        </p:nvSpPr>
        <p:spPr>
          <a:xfrm>
            <a:off x="6798737" y="4039195"/>
            <a:ext cx="109450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07CE1DD6-374D-6411-2798-D3453199F031}"/>
              </a:ext>
            </a:extLst>
          </p:cNvPr>
          <p:cNvSpPr txBox="1"/>
          <p:nvPr/>
        </p:nvSpPr>
        <p:spPr>
          <a:xfrm>
            <a:off x="5926608" y="2177564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CE7DCA4F-DE3B-83B0-F6F9-BCD03946E9B9}"/>
              </a:ext>
            </a:extLst>
          </p:cNvPr>
          <p:cNvSpPr txBox="1"/>
          <p:nvPr/>
        </p:nvSpPr>
        <p:spPr>
          <a:xfrm>
            <a:off x="6278367" y="2188011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D5D0083E-BB4F-64AC-BDE1-07B1B8065BF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200" t="37647" r="38475" b="58333"/>
          <a:stretch/>
        </p:blipFill>
        <p:spPr>
          <a:xfrm>
            <a:off x="4498861" y="3327503"/>
            <a:ext cx="2229013" cy="35535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2B27D813-B26B-FD01-A68A-FBE7E5248A9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569" t="36819" r="45817" b="58961"/>
          <a:stretch/>
        </p:blipFill>
        <p:spPr>
          <a:xfrm>
            <a:off x="4498861" y="4040460"/>
            <a:ext cx="2229013" cy="36806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BBBE35EA-174B-7229-03A5-E5AD21EB33E4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825" t="36390" r="40842" b="57331"/>
          <a:stretch/>
        </p:blipFill>
        <p:spPr>
          <a:xfrm>
            <a:off x="4492995" y="2555903"/>
            <a:ext cx="2229013" cy="55489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1915825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72303" y="102383"/>
            <a:ext cx="3307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6d. Quantification (n=3)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60BA4643-5F80-2419-DC9D-B2EC5AF679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19177" y="1520018"/>
            <a:ext cx="3607223" cy="43214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82028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b="1" dirty="0">
            <a:latin typeface="Times New Roman" panose="02020603050405020304" pitchFamily="18" charset="0"/>
            <a:cs typeface="Times New Roman" panose="02020603050405020304" pitchFamily="18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5</TotalTime>
  <Words>96</Words>
  <Application>Microsoft Office PowerPoint</Application>
  <PresentationFormat>宽屏</PresentationFormat>
  <Paragraphs>58</Paragraphs>
  <Slides>4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Arial Unicode MS</vt:lpstr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eng zhenxiang</dc:creator>
  <cp:lastModifiedBy>zheng zhenxiang</cp:lastModifiedBy>
  <cp:revision>28</cp:revision>
  <dcterms:created xsi:type="dcterms:W3CDTF">2023-06-13T02:19:52Z</dcterms:created>
  <dcterms:modified xsi:type="dcterms:W3CDTF">2023-08-13T05:24:52Z</dcterms:modified>
</cp:coreProperties>
</file>